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2" d="100"/>
          <a:sy n="152" d="100"/>
        </p:scale>
        <p:origin x="1988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3/0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3/0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1369" y="5322385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29600" y="5162785"/>
            <a:ext cx="8155872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Fernández-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Veledo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</a:t>
            </a:r>
            <a:r>
              <a:rPr kumimoji="0" lang="en-GB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/s00125-023-0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6063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The dual nature of succinate: origins and function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278AF56-A72C-6FC0-91AB-F8F2A0B9B4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74767" y="836712"/>
            <a:ext cx="4794466" cy="4757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6</cp:revision>
  <dcterms:created xsi:type="dcterms:W3CDTF">2016-06-15T12:53:43Z</dcterms:created>
  <dcterms:modified xsi:type="dcterms:W3CDTF">2024-01-03T15:43:22Z</dcterms:modified>
</cp:coreProperties>
</file>